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oko Sairenji" initials="TS" lastIdx="0" clrIdx="0">
    <p:extLst/>
  </p:cmAuthor>
  <p:cmAuthor id="2" name="Tomoko Sairenji" initials="TS [2]" lastIdx="1" clrIdx="1">
    <p:extLst/>
  </p:cmAuthor>
  <p:cmAuthor id="3" name="Tomoko Sairenji" initials="TS [3]" lastIdx="1" clrIdx="2">
    <p:extLst/>
  </p:cmAuthor>
  <p:cmAuthor id="4" name="Tomoko Sairenji" initials="TS [4]" lastIdx="1" clrIdx="3">
    <p:extLst/>
  </p:cmAuthor>
  <p:cmAuthor id="5" name="Tomoko Sairenji" initials="TS [5]" lastIdx="1" clrIdx="4">
    <p:extLst/>
  </p:cmAuthor>
  <p:cmAuthor id="6" name="Kinjo Kentaro" initials="KK" lastIdx="1" clrIdx="5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0298" autoAdjust="0"/>
    <p:restoredTop sz="94554"/>
  </p:normalViewPr>
  <p:slideViewPr>
    <p:cSldViewPr snapToGrid="0" snapToObjects="1">
      <p:cViewPr varScale="1">
        <p:scale>
          <a:sx n="109" d="100"/>
          <a:sy n="109" d="100"/>
        </p:scale>
        <p:origin x="-624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7ACC70-A226-B54B-AB86-DD91E35F0DB5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1AD31-08EA-EF40-9D60-49C75BD8C930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14424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279E7-8AD2-144C-87A3-9705D9D9703D}" type="datetimeFigureOut">
              <a:rPr lang="ja-JP" altLang="en-US" smtClean="0"/>
              <a:pPr/>
              <a:t>2016/12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4EB96-4EC7-E94C-83E9-47045EC68CEA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"/>
                <a:cs typeface="Times"/>
              </a:rPr>
              <a:t>Additional file 2. </a:t>
            </a:r>
            <a:r>
              <a:rPr lang="en-US" sz="1600" dirty="0" smtClean="0">
                <a:latin typeface="Times"/>
                <a:cs typeface="Times"/>
              </a:rPr>
              <a:t>Patient profiles with </a:t>
            </a:r>
            <a:r>
              <a:rPr lang="en-US" sz="1600" dirty="0" err="1" smtClean="0">
                <a:latin typeface="Times"/>
                <a:cs typeface="Times"/>
              </a:rPr>
              <a:t>Zaitaku</a:t>
            </a:r>
            <a:r>
              <a:rPr lang="en-US" sz="1600" dirty="0" smtClean="0">
                <a:latin typeface="Times"/>
                <a:cs typeface="Times"/>
              </a:rPr>
              <a:t> care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more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than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30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days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before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dying</a:t>
            </a:r>
            <a:endParaRPr lang="ja-JP" altLang="en-US" sz="1600" dirty="0" smtClean="0">
              <a:latin typeface="Times"/>
              <a:cs typeface="Times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394321244"/>
              </p:ext>
            </p:extLst>
          </p:nvPr>
        </p:nvGraphicFramePr>
        <p:xfrm>
          <a:off x="156754" y="328863"/>
          <a:ext cx="8872946" cy="5257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2069"/>
                <a:gridCol w="459377"/>
                <a:gridCol w="2425701"/>
                <a:gridCol w="355600"/>
                <a:gridCol w="749300"/>
                <a:gridCol w="711200"/>
                <a:gridCol w="927100"/>
                <a:gridCol w="508000"/>
                <a:gridCol w="571500"/>
                <a:gridCol w="762000"/>
                <a:gridCol w="508000"/>
                <a:gridCol w="673099"/>
              </a:tblGrid>
              <a:tr h="274721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/>
                        <a:t>No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/>
                        <a:t>age(‘s)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>
                          <a:solidFill>
                            <a:schemeClr val="tx1"/>
                          </a:solidFill>
                        </a:rPr>
                        <a:t>diseas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altLang="ja-JP" sz="1100" b="1" u="none" strike="noStrike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l" fontAlgn="b"/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days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Medical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>
                          <a:solidFill>
                            <a:schemeClr val="tx1"/>
                          </a:solidFill>
                        </a:rPr>
                        <a:t>Nursing </a:t>
                      </a:r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Transportation</a:t>
                      </a:r>
                      <a:r>
                        <a:rPr lang="ja-JP" altLang="en-US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 </a:t>
                      </a:r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latin typeface="ＭＳ Ｐゴシック"/>
                        </a:rPr>
                        <a:t>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LTCI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Terminal</a:t>
                      </a:r>
                      <a:r>
                        <a:rPr lang="en-US" altLang="ja-JP" sz="1100" b="1" u="none" strike="noStrike" baseline="0" dirty="0" smtClean="0">
                          <a:solidFill>
                            <a:schemeClr val="tx1"/>
                          </a:solidFill>
                        </a:rPr>
                        <a:t> care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Medical</a:t>
                      </a:r>
                    </a:p>
                    <a:p>
                      <a:pPr algn="l" fontAlgn="b"/>
                      <a:r>
                        <a:rPr lang="en-US" altLang="ja-JP" sz="1100" b="1" u="none" strike="noStrike" dirty="0" smtClean="0">
                          <a:solidFill>
                            <a:schemeClr val="tx1"/>
                          </a:solidFill>
                        </a:rPr>
                        <a:t>contract fee</a:t>
                      </a:r>
                      <a:endParaRPr lang="en-US" altLang="ja-JP" sz="1100" b="1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/>
                        <a:t>Total cost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u="none" strike="noStrike" dirty="0"/>
                        <a:t>cost/</a:t>
                      </a:r>
                      <a:r>
                        <a:rPr lang="en-US" altLang="ja-JP" sz="1100" b="1" u="none" strike="noStrike" dirty="0" smtClean="0"/>
                        <a:t>day</a:t>
                      </a:r>
                    </a:p>
                    <a:p>
                      <a:pPr algn="l" fontAlgn="b"/>
                      <a:r>
                        <a:rPr lang="en-US" altLang="ja-JP" sz="1100" b="1" i="0" u="none" strike="noStrike" dirty="0" smtClean="0">
                          <a:latin typeface="ＭＳ Ｐゴシック"/>
                        </a:rPr>
                        <a:t>(US dollar)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/>
                        <a:t>17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7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lung cancer, dementia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hypertension, diabetes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mellitus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909.3</a:t>
                      </a: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842.6</a:t>
                      </a: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4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9499.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316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3577">
                <a:tc>
                  <a:txBody>
                    <a:bodyPr/>
                    <a:lstStyle/>
                    <a:p>
                      <a:pPr marL="0" marR="0" indent="0" algn="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u="none" strike="noStrike" dirty="0" smtClean="0"/>
                        <a:t>18</a:t>
                      </a:r>
                      <a:endParaRPr lang="en-US" altLang="ja-JP" sz="1100" b="1" i="0" u="none" strike="noStrike" dirty="0" smtClean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8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dementia, aspiration pneumon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0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20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21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6524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217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/>
                        <a:t>19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dementia, gastric cancer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acute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respiratory distress syndrome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aspiration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pneumon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60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48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74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6199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206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 smtClean="0"/>
                        <a:t>20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8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gastric cancer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atrial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fibrillation, </a:t>
                      </a:r>
                    </a:p>
                    <a:p>
                      <a:pPr algn="l" fontAlgn="b"/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chronic kidney diseas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069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602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2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40.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6037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201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437">
                <a:tc>
                  <a:txBody>
                    <a:bodyPr/>
                    <a:lstStyle/>
                    <a:p>
                      <a:pPr marL="0" marR="0" indent="0" algn="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u="none" strike="noStrike" dirty="0" smtClean="0"/>
                        <a:t>21</a:t>
                      </a:r>
                      <a:endParaRPr lang="en-US" altLang="ja-JP" sz="1100" b="1" i="0" u="none" strike="noStrike" dirty="0" smtClean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Malignant </a:t>
                      </a:r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mesotheliom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1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91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406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06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9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5899.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96.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2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7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pancreatic cancer, diabetes </a:t>
                      </a:r>
                      <a:r>
                        <a:rPr lang="en-US" altLang="ja-JP" sz="1100" u="none" strike="noStrike" dirty="0" err="1">
                          <a:solidFill>
                            <a:schemeClr val="tx1"/>
                          </a:solidFill>
                        </a:rPr>
                        <a:t>militus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l" fontAlgn="b"/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ascites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 plural fluid 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264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075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20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5760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92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11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3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atrial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fibrillation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epilepsy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5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455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08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59.1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5580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86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627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4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</a:rPr>
                        <a:t>dementia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10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93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74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u="none" strike="noStrike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5161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72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5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atrial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fibrillation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brain </a:t>
                      </a:r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infarction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3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105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6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612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4561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52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6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8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gastric cancer, aspiration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pneumonia,</a:t>
                      </a:r>
                      <a:r>
                        <a:rPr lang="ja-JP" altLang="en-US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endParaRPr lang="en-US" altLang="ja-JP" sz="1100" u="none" strike="noStrike" dirty="0" smtClean="0">
                        <a:solidFill>
                          <a:schemeClr val="tx1"/>
                        </a:solidFill>
                      </a:endParaRP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73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37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45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6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4552.7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51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7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gallbladder cancer, chronic heart failure,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breast cancer, right femoral fracture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029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48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3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17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3728.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24.3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849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8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8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</a:rPr>
                        <a:t>lung cancer, pluritis, angina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283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41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6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480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16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29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chronic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obstructive pulmonary disease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myelodysplastic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syndrome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</a:p>
                    <a:p>
                      <a:pPr algn="l" fontAlgn="b"/>
                      <a:r>
                        <a:rPr lang="en-US" altLang="ja-JP" sz="1100" u="none" strike="noStrike" dirty="0" err="1" smtClean="0">
                          <a:solidFill>
                            <a:schemeClr val="tx1"/>
                          </a:solidFill>
                        </a:rPr>
                        <a:t>cellulitis</a:t>
                      </a:r>
                      <a:r>
                        <a:rPr lang="ja-JP" altLang="ja-JP" sz="1100" u="none" strike="noStrike" dirty="0" smtClean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ja-JP" altLang="en-US" sz="1100" u="none" strike="noStrike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dement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3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30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53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96.4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3053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01.8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087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30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8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</a:rPr>
                        <a:t>pancreatic head cancer, diabetes millitus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69.6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672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27.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3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3005.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00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373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31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6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</a:rPr>
                        <a:t>gastric cancer, diabetes millitus 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1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821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17.5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83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8.3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16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2730.5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91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6597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32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9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</a:rPr>
                        <a:t>dementia, hypertension,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right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hip fracture 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38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491.2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95.8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75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41.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2587.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86.2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721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1" u="none" strike="noStrike" dirty="0"/>
                        <a:t>33</a:t>
                      </a:r>
                      <a:endParaRPr lang="en-US" altLang="ja-JP" sz="1100" b="1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/>
                        <a:t> 60</a:t>
                      </a:r>
                      <a:endParaRPr lang="en-US" altLang="ja-JP" sz="1100" b="0" i="0" u="none" strike="noStrike" dirty="0"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amyotrophic</a:t>
                      </a:r>
                      <a:r>
                        <a:rPr lang="en-US" altLang="ja-JP" sz="1100" u="none" strike="noStrike" baseline="0" dirty="0" smtClean="0">
                          <a:solidFill>
                            <a:schemeClr val="tx1"/>
                          </a:solidFill>
                        </a:rPr>
                        <a:t> lateral sclerosis</a:t>
                      </a:r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, </a:t>
                      </a:r>
                    </a:p>
                    <a:p>
                      <a:pPr algn="l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</a:rPr>
                        <a:t>aspiration pneumonia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ＭＳ Ｐゴシック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57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113.9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00.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1113.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100" u="none" strike="noStrike" dirty="0" smtClean="0">
                          <a:latin typeface="+mn-lt"/>
                        </a:rPr>
                        <a:t>37.1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12700" marR="12700" marT="12700" marB="0" anchor="b">
                    <a:lnL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prstClr val="white">
                          <a:lumMod val="7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01599" y="5640136"/>
            <a:ext cx="21467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100" dirty="0" smtClean="0">
                <a:latin typeface="Times"/>
                <a:cs typeface="Times"/>
              </a:rPr>
              <a:t>LTCI = Long Term Care Insurance</a:t>
            </a:r>
            <a:endParaRPr lang="ja-JP" altLang="en-US" sz="1100" dirty="0" smtClean="0">
              <a:latin typeface="Times"/>
              <a:cs typeface="Time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0" y="5901746"/>
            <a:ext cx="91313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"/>
                <a:cs typeface="Times"/>
              </a:rPr>
              <a:t>     </a:t>
            </a:r>
            <a:r>
              <a:rPr lang="en-US" sz="1600" dirty="0" smtClean="0">
                <a:latin typeface="Times"/>
                <a:cs typeface="Times"/>
              </a:rPr>
              <a:t>Patient profiles with </a:t>
            </a:r>
            <a:r>
              <a:rPr lang="en-US" sz="1600" dirty="0" err="1" smtClean="0">
                <a:latin typeface="Times"/>
                <a:cs typeface="Times"/>
              </a:rPr>
              <a:t>Zaitaku</a:t>
            </a:r>
            <a:r>
              <a:rPr lang="en-US" sz="1600" dirty="0" smtClean="0">
                <a:latin typeface="Times"/>
                <a:cs typeface="Times"/>
              </a:rPr>
              <a:t> care for long term (</a:t>
            </a:r>
            <a:r>
              <a:rPr lang="en-US" altLang="ja-JP" sz="1200" dirty="0" smtClean="0">
                <a:latin typeface="Times New Roman"/>
                <a:cs typeface="Times New Roman"/>
              </a:rPr>
              <a:t>≧</a:t>
            </a:r>
            <a:r>
              <a:rPr lang="en-US" sz="1600" dirty="0" smtClean="0">
                <a:latin typeface="Times"/>
                <a:cs typeface="Times"/>
              </a:rPr>
              <a:t>30 days) were shown. </a:t>
            </a:r>
            <a:r>
              <a:rPr lang="en-GB" sz="1600" dirty="0" smtClean="0">
                <a:latin typeface="Times"/>
                <a:cs typeface="Times"/>
              </a:rPr>
              <a:t>Costs are in US dollar ($1=¥120, exchange rate in 2015).  </a:t>
            </a:r>
            <a:r>
              <a:rPr lang="en-US" sz="1600" dirty="0" smtClean="0">
                <a:latin typeface="Times"/>
                <a:cs typeface="Times"/>
              </a:rPr>
              <a:t>On this table, “0” indicates that the patient did not use the service. The total costs per day are shown in Figure</a:t>
            </a:r>
            <a:r>
              <a:rPr lang="ja-JP" altLang="en-US" sz="1600" dirty="0" smtClean="0">
                <a:latin typeface="Times"/>
                <a:cs typeface="Times"/>
              </a:rPr>
              <a:t> </a:t>
            </a:r>
            <a:r>
              <a:rPr lang="en-US" altLang="ja-JP" sz="1600" dirty="0" smtClean="0">
                <a:latin typeface="Times"/>
                <a:cs typeface="Times"/>
              </a:rPr>
              <a:t>1</a:t>
            </a:r>
            <a:r>
              <a:rPr lang="en-US" sz="1600" dirty="0" smtClean="0">
                <a:latin typeface="Times"/>
                <a:cs typeface="Times"/>
              </a:rPr>
              <a:t>.</a:t>
            </a:r>
            <a:endParaRPr kumimoji="1" lang="ja-JP" altLang="en-US" sz="1600" dirty="0">
              <a:latin typeface="Times"/>
              <a:cs typeface="Times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47</TotalTime>
  <Words>432</Words>
  <Application>Microsoft Office PowerPoint</Application>
  <PresentationFormat>On-screen Show (4:3)</PresentationFormat>
  <Paragraphs>2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injo Kentaro</dc:creator>
  <cp:lastModifiedBy>wdesales</cp:lastModifiedBy>
  <cp:revision>66</cp:revision>
  <cp:lastPrinted>2016-10-09T11:29:40Z</cp:lastPrinted>
  <dcterms:created xsi:type="dcterms:W3CDTF">2016-09-24T21:25:17Z</dcterms:created>
  <dcterms:modified xsi:type="dcterms:W3CDTF">2016-12-17T03:07:01Z</dcterms:modified>
</cp:coreProperties>
</file>